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1498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2337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2360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711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1835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590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8935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85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6472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713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92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114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97B95-C6D9-453C-B924-1B2C74285BBC}" type="datetimeFigureOut">
              <a:rPr lang="en-GB" smtClean="0"/>
              <a:t>19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CB59C-987E-4A99-B83B-E5DEDF919D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2878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8168515"/>
              </p:ext>
            </p:extLst>
          </p:nvPr>
        </p:nvGraphicFramePr>
        <p:xfrm>
          <a:off x="955675" y="879475"/>
          <a:ext cx="7234238" cy="5099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7234046" imgH="5098341" progId="Prism5.Document">
                  <p:embed/>
                </p:oleObj>
              </mc:Choice>
              <mc:Fallback>
                <p:oleObj name="Prism 5" r:id="rId2" imgW="7234046" imgH="5098341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55675" y="879475"/>
                        <a:ext cx="7234238" cy="5099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97411" y="2969244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62295" y="2972158"/>
            <a:ext cx="619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128887" y="2967760"/>
            <a:ext cx="89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208447" y="2981394"/>
            <a:ext cx="1167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/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436096" y="2990630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542575" y="3012016"/>
            <a:ext cx="619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889079" y="3021252"/>
            <a:ext cx="89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047132" y="3002780"/>
            <a:ext cx="1167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/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52827" y="5705548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812057" y="5725928"/>
            <a:ext cx="619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178649" y="5716915"/>
            <a:ext cx="89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63863" y="5717698"/>
            <a:ext cx="1167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/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436096" y="5732654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598134" y="5744804"/>
            <a:ext cx="6190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002035" y="5724532"/>
            <a:ext cx="8931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047132" y="5744804"/>
            <a:ext cx="11676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UCP1/FGF21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9" name="Rectangle 18"/>
          <p:cNvSpPr/>
          <p:nvPr/>
        </p:nvSpPr>
        <p:spPr>
          <a:xfrm rot="16200000">
            <a:off x="327550" y="1958486"/>
            <a:ext cx="14638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imordial follicle (#)</a:t>
            </a:r>
          </a:p>
        </p:txBody>
      </p:sp>
      <p:sp>
        <p:nvSpPr>
          <p:cNvPr id="20" name="Rectangle 19"/>
          <p:cNvSpPr/>
          <p:nvPr/>
        </p:nvSpPr>
        <p:spPr>
          <a:xfrm rot="16200000">
            <a:off x="4190231" y="1958486"/>
            <a:ext cx="131318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rimary follicle (#)</a:t>
            </a:r>
          </a:p>
        </p:txBody>
      </p:sp>
      <p:sp>
        <p:nvSpPr>
          <p:cNvPr id="21" name="Rectangle 20"/>
          <p:cNvSpPr/>
          <p:nvPr/>
        </p:nvSpPr>
        <p:spPr>
          <a:xfrm rot="16200000">
            <a:off x="341227" y="4609396"/>
            <a:ext cx="14702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eantral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follicles (#)</a:t>
            </a:r>
          </a:p>
        </p:txBody>
      </p:sp>
      <p:sp>
        <p:nvSpPr>
          <p:cNvPr id="22" name="Rectangle 21"/>
          <p:cNvSpPr/>
          <p:nvPr/>
        </p:nvSpPr>
        <p:spPr>
          <a:xfrm rot="16200000">
            <a:off x="4261156" y="4655771"/>
            <a:ext cx="126669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tral follicles (#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05912" y="759490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678478" y="759490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23136" y="3501008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706780" y="3653408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TextBox 1">
            <a:extLst>
              <a:ext uri="{FF2B5EF4-FFF2-40B4-BE49-F238E27FC236}">
                <a16:creationId xmlns:a16="http://schemas.microsoft.com/office/drawing/2014/main" id="{ED062773-0D87-497A-ACC0-FF22D5FA2FB4}"/>
              </a:ext>
            </a:extLst>
          </p:cNvPr>
          <p:cNvSpPr txBox="1"/>
          <p:nvPr/>
        </p:nvSpPr>
        <p:spPr>
          <a:xfrm>
            <a:off x="7189938" y="294474"/>
            <a:ext cx="15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S</a:t>
            </a:r>
            <a:r>
              <a:rPr lang="en-US" altLang="zh-CN" sz="1200" dirty="0"/>
              <a:t>upplemental </a:t>
            </a:r>
            <a:r>
              <a:rPr lang="en-US" sz="1200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4092452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8</TotalTime>
  <Words>51</Words>
  <Application>Microsoft Office PowerPoint</Application>
  <PresentationFormat>全屏显示(4:3)</PresentationFormat>
  <Paragraphs>25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5</vt:lpstr>
      <vt:lpstr>PowerPoint 演示文稿</vt:lpstr>
    </vt:vector>
  </TitlesOfParts>
  <Company>Wageningen U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g, Li</dc:creator>
  <cp:lastModifiedBy>Meng Li</cp:lastModifiedBy>
  <cp:revision>35</cp:revision>
  <dcterms:created xsi:type="dcterms:W3CDTF">2016-07-04T18:34:14Z</dcterms:created>
  <dcterms:modified xsi:type="dcterms:W3CDTF">2020-12-19T15:42:57Z</dcterms:modified>
</cp:coreProperties>
</file>